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326987-2DF3-4293-B03C-37BAD7308D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556E3E-15A3-42B4-BB6D-5599786FAD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9EE82-43B0-4C1D-BD54-EBAD04E2E9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7284BF-F2B0-4EBA-8F89-44504F3374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51DD5F-7E58-4AF4-B6A2-B826C980DA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EC60D-48D3-4F4D-BE31-A7AFB113CC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EA55B-8FFE-42FA-AF7C-F2D7227443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DEA84-44EB-482B-98DD-9822567AB1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B1FAE-F115-4089-8B92-5EEC3A82D5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91B0E7-564D-492B-A74F-057D32B496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994BA-B6CD-4FA3-B722-4758BD3818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55C13-291C-467F-9866-C1E95033E9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7720" y="131760"/>
            <a:ext cx="313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NL" sz="1200" spc="-1" strike="noStrike">
                <a:solidFill>
                  <a:srgbClr val="000000"/>
                </a:solidFill>
                <a:latin typeface="Arial"/>
              </a:rPr>
              <a:t>Kleemann et al., 2007, Additional data file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1484280" y="3086280"/>
            <a:ext cx="3529080" cy="242244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2707560" y="2987640"/>
            <a:ext cx="3636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spcBef>
                <a:spcPts val="26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700" spc="-1" strike="noStrike">
                <a:solidFill>
                  <a:srgbClr val="000000"/>
                </a:solidFill>
                <a:latin typeface="Arial"/>
              </a:rPr>
              <a:t>EP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76280" y="899280"/>
            <a:ext cx="57610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data file 5: Comprehensive analysis of gene and metabolite data (MetaCore™ network software)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iological network based on differentially expressed genes controlled by SREBP1 with green symbols on arrows indicating ‘transcription factor’ and        indicating the metabolite eicosanpentaenoic acid (EPA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970520" y="1511280"/>
            <a:ext cx="216000" cy="144360"/>
          </a:xfrm>
          <a:prstGeom prst="hexagon">
            <a:avLst>
              <a:gd name="adj" fmla="val 37406"/>
              <a:gd name="vf" fmla="val 115470"/>
            </a:avLst>
          </a:prstGeom>
          <a:solidFill>
            <a:srgbClr val="aa21e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4280" bIns="44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B67F5-ECD8-4495-80A3-C3F475B296B2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3-16T09:17:31Z</dcterms:created>
  <dc:creator>verschl</dc:creator>
  <dc:description/>
  <dc:language>en-US</dc:language>
  <cp:lastModifiedBy>kleemannr</cp:lastModifiedBy>
  <dcterms:modified xsi:type="dcterms:W3CDTF">2007-07-13T09:49:24Z</dcterms:modified>
  <cp:revision>126</cp:revision>
  <dc:subject/>
  <dc:title>Dia 1</dc:title>
</cp:coreProperties>
</file>